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2" autoAdjust="0"/>
    <p:restoredTop sz="94660"/>
  </p:normalViewPr>
  <p:slideViewPr>
    <p:cSldViewPr snapToGrid="0">
      <p:cViewPr varScale="1">
        <p:scale>
          <a:sx n="63" d="100"/>
          <a:sy n="63" d="100"/>
        </p:scale>
        <p:origin x="76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12493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25600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5286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2064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5547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149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943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084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40631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5379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58763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A1C593-65D0-4073-BCC9-577B9352EA97}" type="datetimeFigureOut">
              <a:rPr lang="en-US" smtClean="0"/>
              <a:t>12/1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618960-8005-486C-9A75-10CB2AAC1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3008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395C31-037C-635C-3EF2-E5C05A0810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74320" y="4602480"/>
            <a:ext cx="11724640" cy="2086929"/>
          </a:xfrm>
        </p:spPr>
        <p:txBody>
          <a:bodyPr>
            <a:noAutofit/>
          </a:bodyPr>
          <a:lstStyle/>
          <a:p>
            <a:pPr marL="0" marR="0">
              <a:lnSpc>
                <a:spcPct val="200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2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typical presentations of WGDCs.</a:t>
            </a:r>
            <a:b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r>
              <a:rPr lang="en-US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 </a:t>
            </a:r>
            <a:r>
              <a:rPr lang="en-US" sz="1200" b="0" dirty="0" err="1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sz="12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38-year-old woman presented with right upper lid painful swelling.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B </a:t>
            </a:r>
            <a:r>
              <a:rPr lang="en-US" sz="12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cystic lesion with whitish opaque material inside (infected cyst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sz="12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 37-year-old woman presented with right upper lid swelling that increased in size dramatically causing complete ptosis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 </a:t>
            </a:r>
            <a:r>
              <a:rPr lang="en-US" sz="12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 chocolate colored cyst (Hemorrhage in a cyst).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E,F</a:t>
            </a:r>
            <a:r>
              <a:rPr lang="en-US" sz="1200" b="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 55-year-old woman presented with a recurrent large mass in the right upper lid with complete ptosis. The patient underwent  repeated needle aspiration over a couple of years and the cyst refills rapidly after being drained.</a:t>
            </a:r>
            <a:br>
              <a:rPr lang="en-US" sz="1200" dirty="0">
                <a:effectLst/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</a:b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 descr="A collage of different eye diseases&#10;&#10;Description automatically generated">
            <a:extLst>
              <a:ext uri="{FF2B5EF4-FFF2-40B4-BE49-F238E27FC236}">
                <a16:creationId xmlns:a16="http://schemas.microsoft.com/office/drawing/2014/main" id="{205EA136-5E55-2CAA-689B-F666326F01A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56777" y="168592"/>
            <a:ext cx="5125486" cy="4351338"/>
          </a:xfrm>
        </p:spPr>
      </p:pic>
    </p:spTree>
    <p:extLst>
      <p:ext uri="{BB962C8B-B14F-4D97-AF65-F5344CB8AC3E}">
        <p14:creationId xmlns:p14="http://schemas.microsoft.com/office/powerpoint/2010/main" val="5169393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07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ry figure2. Atypical presentations of WGDCs.  A A 38-year-old woman presented with right upper lid painful swelling. B A cystic lesion with whitish opaque material inside (infected cyst). C A 37-year-old woman presented with right upper lid swelling that increased in size dramatically causing complete ptosis. D A chocolate colored cyst (Hemorrhage in a cyst). E,F A 55-year-old woman presented with a recurrent large mass in the right upper lid with complete ptosis. The patient underwent  repeated needle aspiration over a couple of years and the cyst refills rapidly after being drained.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WPS Presentation</dc:title>
  <dc:creator>mosta</dc:creator>
  <cp:lastModifiedBy>Mahmoud Mohamed Diab</cp:lastModifiedBy>
  <cp:revision>1</cp:revision>
  <dcterms:created xsi:type="dcterms:W3CDTF">2023-12-18T04:57:07Z</dcterms:created>
  <dcterms:modified xsi:type="dcterms:W3CDTF">2023-12-18T04:59:39Z</dcterms:modified>
</cp:coreProperties>
</file>